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1566" y="10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2/08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0" y="91207"/>
            <a:ext cx="6858000" cy="10772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Table 3.</a:t>
            </a:r>
            <a:r>
              <a:rPr kumimoji="0" lang="en-US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Quantification of band intensities for blot reported in Figure 4C and E.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Quantification was performed using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ImageJ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Arial" pitchFamily="34" charset="0"/>
              </a:rPr>
              <a:t>1.47q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oftware. After normalization to corresponding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Helvetica"/>
              </a:rPr>
              <a:t>β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-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actin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, normalized values for each treatment (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irolimu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t different doses or siATF4/5) were compared to the corresponding band of the untreated (control) sample or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iNEG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sample. 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20688" y="821326"/>
            <a:ext cx="5400600" cy="67039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6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valentina</cp:lastModifiedBy>
  <cp:revision>13</cp:revision>
  <dcterms:created xsi:type="dcterms:W3CDTF">2024-08-02T07:16:01Z</dcterms:created>
  <dcterms:modified xsi:type="dcterms:W3CDTF">2024-08-02T07:38:36Z</dcterms:modified>
</cp:coreProperties>
</file>